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559675" cy="51120675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101">
          <p15:clr>
            <a:srgbClr val="A4A3A4"/>
          </p15:clr>
        </p15:guide>
        <p15:guide id="2" pos="238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9" autoAdjust="0"/>
    <p:restoredTop sz="94660"/>
  </p:normalViewPr>
  <p:slideViewPr>
    <p:cSldViewPr snapToGrid="0">
      <p:cViewPr>
        <p:scale>
          <a:sx n="177" d="100"/>
          <a:sy n="177" d="100"/>
        </p:scale>
        <p:origin x="424" y="-52224"/>
      </p:cViewPr>
      <p:guideLst>
        <p:guide orient="horz" pos="16101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8366281"/>
            <a:ext cx="6425724" cy="17797568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26850192"/>
            <a:ext cx="5669756" cy="12342326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D1D367-998F-4AC2-B242-EAF98C917FC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2A4B6-B2D1-4882-8C5B-96C93823BD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0108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D1D367-998F-4AC2-B242-EAF98C917FC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2A4B6-B2D1-4882-8C5B-96C93823BD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1770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2721703"/>
            <a:ext cx="1630055" cy="4332240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2721703"/>
            <a:ext cx="4795669" cy="4332240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D1D367-998F-4AC2-B242-EAF98C917FC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2A4B6-B2D1-4882-8C5B-96C93823BD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8616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D1D367-998F-4AC2-B242-EAF98C917FC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2A4B6-B2D1-4882-8C5B-96C93823BD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2697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12744683"/>
            <a:ext cx="6520220" cy="21264777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34210633"/>
            <a:ext cx="6520220" cy="11182644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D1D367-998F-4AC2-B242-EAF98C917FC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2A4B6-B2D1-4882-8C5B-96C93823BD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8178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13608513"/>
            <a:ext cx="3212862" cy="3243559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13608513"/>
            <a:ext cx="3212862" cy="3243559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D1D367-998F-4AC2-B242-EAF98C917FC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2A4B6-B2D1-4882-8C5B-96C93823BD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25359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2721714"/>
            <a:ext cx="6520220" cy="9880968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12531669"/>
            <a:ext cx="3198096" cy="61415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18673247"/>
            <a:ext cx="3198096" cy="2746553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12531669"/>
            <a:ext cx="3213847" cy="6141577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18673247"/>
            <a:ext cx="3213847" cy="2746553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D1D367-998F-4AC2-B242-EAF98C917FC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2A4B6-B2D1-4882-8C5B-96C93823BD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1505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D1D367-998F-4AC2-B242-EAF98C917FC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2A4B6-B2D1-4882-8C5B-96C93823BD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4060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D1D367-998F-4AC2-B242-EAF98C917FC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2A4B6-B2D1-4882-8C5B-96C93823BD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191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3408045"/>
            <a:ext cx="2438192" cy="1192815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7360442"/>
            <a:ext cx="3827085" cy="36328813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15336203"/>
            <a:ext cx="2438192" cy="2841221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D1D367-998F-4AC2-B242-EAF98C917FC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2A4B6-B2D1-4882-8C5B-96C93823BD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00764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3408045"/>
            <a:ext cx="2438192" cy="1192815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7360442"/>
            <a:ext cx="3827085" cy="36328813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15336203"/>
            <a:ext cx="2438192" cy="2841221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D1D367-998F-4AC2-B242-EAF98C917FC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F2A4B6-B2D1-4882-8C5B-96C93823BD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0962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2721714"/>
            <a:ext cx="6520220" cy="98809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13608513"/>
            <a:ext cx="6520220" cy="3243559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47381303"/>
            <a:ext cx="1700927" cy="27217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D1D367-998F-4AC2-B242-EAF98C917FCD}" type="datetimeFigureOut">
              <a:rPr kumimoji="1" lang="ja-JP" altLang="en-US" smtClean="0"/>
              <a:t>2019/2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47381303"/>
            <a:ext cx="2551390" cy="27217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47381303"/>
            <a:ext cx="1700927" cy="27217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F2A4B6-B2D1-4882-8C5B-96C93823BD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980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kumimoji="1"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6555" y="0"/>
            <a:ext cx="5806564" cy="51120675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321468" y="50659010"/>
            <a:ext cx="71334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/>
                <a:ea typeface="Arial Unicode MS" panose="020B0604020202020204" pitchFamily="50" charset="-128"/>
                <a:cs typeface="Arial"/>
              </a:rPr>
              <a:t>Figure S4. </a:t>
            </a:r>
            <a:r>
              <a:rPr lang="en-US" altLang="ja-JP" sz="1200" dirty="0">
                <a:latin typeface="Arial"/>
                <a:ea typeface="Arial Unicode MS" panose="020B0604020202020204" pitchFamily="50" charset="-128"/>
                <a:cs typeface="Arial"/>
              </a:rPr>
              <a:t>A phylogenetic tree based on the amino-acid sequences of DNA gyrase subunit B for 296 species. </a:t>
            </a:r>
            <a:endParaRPr kumimoji="1" lang="ja-JP" altLang="en-US" sz="1200" dirty="0">
              <a:latin typeface="Arial"/>
              <a:ea typeface="Arial Unicode MS" panose="020B0604020202020204" pitchFamily="50" charset="-128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4687041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20</Words>
  <Application>Microsoft Macintosh PowerPoint</Application>
  <PresentationFormat>ユーザー設定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tuyama</dc:creator>
  <cp:lastModifiedBy>五十嵐洋治</cp:lastModifiedBy>
  <cp:revision>9</cp:revision>
  <dcterms:created xsi:type="dcterms:W3CDTF">2018-08-17T08:07:10Z</dcterms:created>
  <dcterms:modified xsi:type="dcterms:W3CDTF">2019-02-20T05:20:13Z</dcterms:modified>
</cp:coreProperties>
</file>